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77" d="100"/>
          <a:sy n="77" d="100"/>
        </p:scale>
        <p:origin x="-1092" y="45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 l="2343" t="8333" r="2782" b="1042"/>
          <a:stretch>
            <a:fillRect/>
          </a:stretch>
        </p:blipFill>
        <p:spPr bwMode="auto">
          <a:xfrm>
            <a:off x="152400" y="71422"/>
            <a:ext cx="8534400" cy="60245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Rectangle 6"/>
          <p:cNvSpPr/>
          <p:nvPr/>
        </p:nvSpPr>
        <p:spPr>
          <a:xfrm>
            <a:off x="304800" y="6211669"/>
            <a:ext cx="8686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b="1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5 </a:t>
            </a:r>
            <a:r>
              <a:rPr lang="en-US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Distribution of conserved motifs in </a:t>
            </a:r>
            <a:r>
              <a:rPr lang="en-US" dirty="0" err="1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bPRPs</a:t>
            </a:r>
            <a:r>
              <a:rPr lang="en-US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nd The scale represents the lengths of the proteins and motifs </a:t>
            </a:r>
            <a:endParaRPr lang="en-US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4</cp:revision>
  <dcterms:created xsi:type="dcterms:W3CDTF">2006-08-16T00:00:00Z</dcterms:created>
  <dcterms:modified xsi:type="dcterms:W3CDTF">2022-08-06T06:49:25Z</dcterms:modified>
</cp:coreProperties>
</file>